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56" r:id="rId2"/>
  </p:sldIdLst>
  <p:sldSz cx="8229600" cy="12801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1236" y="-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095078"/>
            <a:ext cx="6995160" cy="4456853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6723804"/>
            <a:ext cx="6172200" cy="3090756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053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744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681567"/>
            <a:ext cx="1774508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681567"/>
            <a:ext cx="5220653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494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325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3191514"/>
            <a:ext cx="7098030" cy="5325109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8567000"/>
            <a:ext cx="7098030" cy="280034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165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3407833"/>
            <a:ext cx="349758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3407833"/>
            <a:ext cx="349758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6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81570"/>
            <a:ext cx="7098030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3138171"/>
            <a:ext cx="3481506" cy="153796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4676140"/>
            <a:ext cx="3481506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3138171"/>
            <a:ext cx="3498652" cy="1537969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4676140"/>
            <a:ext cx="3498652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470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612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921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853440"/>
            <a:ext cx="2654260" cy="298704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843196"/>
            <a:ext cx="4166235" cy="9097433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840480"/>
            <a:ext cx="2654260" cy="7114964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703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853440"/>
            <a:ext cx="2654260" cy="298704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843196"/>
            <a:ext cx="4166235" cy="9097433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840480"/>
            <a:ext cx="2654260" cy="7114964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227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681570"/>
            <a:ext cx="7098030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3407833"/>
            <a:ext cx="7098030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11865189"/>
            <a:ext cx="18516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11865189"/>
            <a:ext cx="277749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11865189"/>
            <a:ext cx="185166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092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604E2AB-63F9-C25D-22C9-E0A33C204541}"/>
              </a:ext>
            </a:extLst>
          </p:cNvPr>
          <p:cNvCxnSpPr>
            <a:cxnSpLocks/>
          </p:cNvCxnSpPr>
          <p:nvPr/>
        </p:nvCxnSpPr>
        <p:spPr>
          <a:xfrm flipV="1">
            <a:off x="-1600" y="2676261"/>
            <a:ext cx="8229600" cy="10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8A9F235-A433-2292-CFEA-3F1AE7628C68}"/>
              </a:ext>
            </a:extLst>
          </p:cNvPr>
          <p:cNvCxnSpPr>
            <a:cxnSpLocks/>
          </p:cNvCxnSpPr>
          <p:nvPr/>
        </p:nvCxnSpPr>
        <p:spPr>
          <a:xfrm>
            <a:off x="-1600" y="7316503"/>
            <a:ext cx="822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DF41B57-02CF-20D0-D45E-0FEA3659F07E}"/>
              </a:ext>
            </a:extLst>
          </p:cNvPr>
          <p:cNvCxnSpPr>
            <a:cxnSpLocks/>
          </p:cNvCxnSpPr>
          <p:nvPr/>
        </p:nvCxnSpPr>
        <p:spPr>
          <a:xfrm>
            <a:off x="-22247" y="5403581"/>
            <a:ext cx="822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58FEA1AB-7621-A533-4832-E3F3C071E7A5}"/>
              </a:ext>
            </a:extLst>
          </p:cNvPr>
          <p:cNvSpPr txBox="1"/>
          <p:nvPr/>
        </p:nvSpPr>
        <p:spPr>
          <a:xfrm>
            <a:off x="108888" y="5426428"/>
            <a:ext cx="70102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rt failure hospitalization in patients with acute heart failure</a:t>
            </a:r>
            <a:endParaRPr lang="en-US" sz="1100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5E0D2EF-92C7-DA29-CE73-6CB02A2E0E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6" y="5733234"/>
            <a:ext cx="8223294" cy="15240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29C616F-C251-5C9A-3976-E0CA41D93C0A}"/>
              </a:ext>
            </a:extLst>
          </p:cNvPr>
          <p:cNvSpPr txBox="1"/>
          <p:nvPr/>
        </p:nvSpPr>
        <p:spPr>
          <a:xfrm>
            <a:off x="108889" y="7333437"/>
            <a:ext cx="70102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rt failure hospitalization in patients with chronic heart failure</a:t>
            </a:r>
            <a:endParaRPr lang="en-US" sz="11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F157992-E10E-482B-2670-A36AD525E4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041087"/>
            <a:ext cx="8229600" cy="249656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DB8313D-9CDE-DCB0-4781-610BB4BD52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6" y="7622770"/>
            <a:ext cx="8229600" cy="2133600"/>
          </a:xfrm>
          <a:prstGeom prst="rect">
            <a:avLst/>
          </a:prstGeom>
        </p:spPr>
      </p:pic>
      <p:sp>
        <p:nvSpPr>
          <p:cNvPr id="14" name="Text Box 1">
            <a:extLst>
              <a:ext uri="{FF2B5EF4-FFF2-40B4-BE49-F238E27FC236}">
                <a16:creationId xmlns:a16="http://schemas.microsoft.com/office/drawing/2014/main" id="{62A61502-E72B-04D3-2FAC-11C0A7C233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889" y="9764837"/>
            <a:ext cx="7480033" cy="2769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434" tIns="21217" rIns="42434" bIns="21217" numCol="1" anchor="t" anchorCtr="0" compatLnSpc="1">
            <a:prstTxWarp prst="textNoShape">
              <a:avLst/>
            </a:prstTxWarp>
          </a:bodyPr>
          <a:lstStyle/>
          <a:p>
            <a:pPr defTabSz="424387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art failure hospitalization for studies using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erric </a:t>
            </a:r>
            <a:r>
              <a:rPr lang="en-US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arboxymaltose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CM)</a:t>
            </a:r>
            <a:endParaRPr lang="en-US" altLang="en-US" sz="1100" dirty="0">
              <a:latin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427F849-13B0-8450-F32A-024E442428D7}"/>
              </a:ext>
            </a:extLst>
          </p:cNvPr>
          <p:cNvCxnSpPr>
            <a:cxnSpLocks/>
          </p:cNvCxnSpPr>
          <p:nvPr/>
        </p:nvCxnSpPr>
        <p:spPr>
          <a:xfrm>
            <a:off x="0" y="9747902"/>
            <a:ext cx="8229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C195DD2C-4E58-16BB-51D6-4A08BE531FD6}"/>
              </a:ext>
            </a:extLst>
          </p:cNvPr>
          <p:cNvSpPr txBox="1"/>
          <p:nvPr/>
        </p:nvSpPr>
        <p:spPr>
          <a:xfrm>
            <a:off x="65575" y="19269"/>
            <a:ext cx="853459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e of heart failure hospitalization or cardiovascular mortality including only studies with &gt;100 sample size at each group</a:t>
            </a:r>
            <a:endParaRPr lang="en-US" sz="1100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B1D1656-004F-9463-1459-B19BF90D8B6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6" y="320146"/>
            <a:ext cx="8228000" cy="2286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7CD8029-7667-D9FE-A7BE-A9086E2DD09E}"/>
              </a:ext>
            </a:extLst>
          </p:cNvPr>
          <p:cNvSpPr txBox="1"/>
          <p:nvPr/>
        </p:nvSpPr>
        <p:spPr>
          <a:xfrm>
            <a:off x="65574" y="2683972"/>
            <a:ext cx="853459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e of heart failure hospitalization or cardiovascular mortality including only studies </a:t>
            </a:r>
            <a:r>
              <a:rPr lang="en-US" altLang="en-US" sz="11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</a:t>
            </a:r>
            <a:r>
              <a:rPr lang="en-US" sz="1100" b="1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llow-up &gt;3 months </a:t>
            </a:r>
            <a:endParaRPr lang="en-US" sz="1100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84A38F6-BF3D-75FF-92E5-09A14DDE3D8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8" y="3040615"/>
            <a:ext cx="8225122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3974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14</TotalTime>
  <Words>64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y ghonim</dc:creator>
  <cp:lastModifiedBy>Mohamed Atef</cp:lastModifiedBy>
  <cp:revision>21</cp:revision>
  <dcterms:created xsi:type="dcterms:W3CDTF">2022-12-15T05:23:43Z</dcterms:created>
  <dcterms:modified xsi:type="dcterms:W3CDTF">2023-04-22T20:10:43Z</dcterms:modified>
</cp:coreProperties>
</file>